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2" r:id="rId2"/>
    <p:sldId id="263" r:id="rId3"/>
    <p:sldId id="264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1" d="100"/>
          <a:sy n="101" d="100"/>
        </p:scale>
        <p:origin x="1836" y="108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3/03/202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ABAA941-7AF8-95BB-C218-1361CC868BA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90FD8D47-78F0-8493-5C36-DC337873757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B9CD4C83-5B8C-6494-C1E1-94A91005AD6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9058CD1-3190-3A77-4EA3-6FD2CDF77037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3027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B3C9932-6DA5-B793-5159-EAF480A0B1B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546B951A-6E56-1121-C84A-564C70B774B0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A8452D6B-F054-9D8D-17E6-AF5E8040A14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DB40C6-2238-EAEE-349D-A36281E4B8C9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31746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CC4C4EC-29FD-DE80-BDB7-51AEA23191E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538971A6-C846-ACFB-4BAF-177CEB0BFC2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0B365795-2289-17EA-55C3-9F2EB76D92B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4FCFF9-FED5-D887-E753-57ED1F44338C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8209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3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3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3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3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3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3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3/2026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3/2026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3/2026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3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3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3/03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5C13EE7-2E61-EBF4-77E1-31BB245374C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57B9C837-57D1-A017-7740-3E611E80E13D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5488BCB-3385-8094-7DA4-4F16310821E3}"/>
              </a:ext>
            </a:extLst>
          </p:cNvPr>
          <p:cNvSpPr txBox="1"/>
          <p:nvPr/>
        </p:nvSpPr>
        <p:spPr>
          <a:xfrm>
            <a:off x="232552" y="5386739"/>
            <a:ext cx="684076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arr et al (2026) Diabetologia DOI 10.1007/s00125-026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707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5DAA2AC-BACE-4E66-67DC-6CA707DE4AA7}"/>
              </a:ext>
            </a:extLst>
          </p:cNvPr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Schematic of the relative burden and informational value of current metabolic monitoring tools in early-stage type 1 diabetes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B13C519-8897-E4AC-2B63-FE103967313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31280" y="1124744"/>
            <a:ext cx="4081440" cy="44312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90362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04B0C9C-890C-AB51-DD40-EC576BBE25D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7605D672-FA0E-EE39-E216-129836B23F55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CAF3A22-BE87-08DD-F41A-6EA0EA20ECF5}"/>
              </a:ext>
            </a:extLst>
          </p:cNvPr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Continuous glucose monitoring metrics associated with progression in early-stage type 1 diabetes</a:t>
            </a:r>
            <a:endParaRPr lang="en-GB" sz="1800" b="1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3357E994-546E-4FB1-B259-FFF1BDCB2E1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15496" y="1052736"/>
            <a:ext cx="6313008" cy="456973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1FF964B-029A-DB20-0945-BCA084693817}"/>
              </a:ext>
            </a:extLst>
          </p:cNvPr>
          <p:cNvSpPr txBox="1"/>
          <p:nvPr/>
        </p:nvSpPr>
        <p:spPr>
          <a:xfrm>
            <a:off x="232552" y="5386739"/>
            <a:ext cx="684076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arr et al (2026) Diabetologia DOI 10.1007/s00125-026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707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978432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130B2E2-B3B5-DDCC-4550-77D19AB2DCC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57E97D41-EE67-62DE-06FB-7264225EC228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2064FD1-15AD-C21D-0392-0FCF1149F878}"/>
              </a:ext>
            </a:extLst>
          </p:cNvPr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Schematic overview of the potential utility of and key barriers to implementing continuous glucose monitoring in early-stage type 1 diabetes</a:t>
            </a:r>
            <a:endParaRPr lang="en-GB" sz="18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031C5DB-C0E9-895F-1D27-83D8C790F20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08778" y="1278906"/>
            <a:ext cx="3726443" cy="430018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6C44229-F8D0-B997-9C00-B1F25F264CFD}"/>
              </a:ext>
            </a:extLst>
          </p:cNvPr>
          <p:cNvSpPr txBox="1"/>
          <p:nvPr/>
        </p:nvSpPr>
        <p:spPr>
          <a:xfrm>
            <a:off x="232552" y="5386739"/>
            <a:ext cx="684076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arr et al (2026) Diabetologia DOI 10.1007/s00125-026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707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3782322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3</Words>
  <Application>Microsoft Office PowerPoint</Application>
  <PresentationFormat>On-screen Show (4:3)</PresentationFormat>
  <Paragraphs>18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9</cp:revision>
  <dcterms:created xsi:type="dcterms:W3CDTF">2016-06-15T12:53:43Z</dcterms:created>
  <dcterms:modified xsi:type="dcterms:W3CDTF">2026-03-03T11:42:57Z</dcterms:modified>
</cp:coreProperties>
</file>